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75" autoAdjust="0"/>
    <p:restoredTop sz="85363" autoAdjust="0"/>
  </p:normalViewPr>
  <p:slideViewPr>
    <p:cSldViewPr snapToGrid="0">
      <p:cViewPr varScale="1">
        <p:scale>
          <a:sx n="87" d="100"/>
          <a:sy n="87" d="100"/>
        </p:scale>
        <p:origin x="16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6EE6A1-079E-4BFD-B60D-01FF45C17B42}" type="datetimeFigureOut">
              <a:rPr kumimoji="1" lang="ja-JP" altLang="en-US" smtClean="0"/>
              <a:t>2019/12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C3D294-0A3B-45F1-87EE-615A256F04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93669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8CC5B-1855-49EF-ACD6-32FCFA6BEC0A}" type="datetimeFigureOut">
              <a:rPr kumimoji="1" lang="ja-JP" altLang="en-US" smtClean="0"/>
              <a:t>2019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2959B-B7A4-4334-828C-1A610744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907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8CC5B-1855-49EF-ACD6-32FCFA6BEC0A}" type="datetimeFigureOut">
              <a:rPr kumimoji="1" lang="ja-JP" altLang="en-US" smtClean="0"/>
              <a:t>2019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2959B-B7A4-4334-828C-1A610744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9774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8CC5B-1855-49EF-ACD6-32FCFA6BEC0A}" type="datetimeFigureOut">
              <a:rPr kumimoji="1" lang="ja-JP" altLang="en-US" smtClean="0"/>
              <a:t>2019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2959B-B7A4-4334-828C-1A610744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0271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8CC5B-1855-49EF-ACD6-32FCFA6BEC0A}" type="datetimeFigureOut">
              <a:rPr kumimoji="1" lang="ja-JP" altLang="en-US" smtClean="0"/>
              <a:t>2019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2959B-B7A4-4334-828C-1A610744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7070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8CC5B-1855-49EF-ACD6-32FCFA6BEC0A}" type="datetimeFigureOut">
              <a:rPr kumimoji="1" lang="ja-JP" altLang="en-US" smtClean="0"/>
              <a:t>2019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2959B-B7A4-4334-828C-1A610744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6368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8CC5B-1855-49EF-ACD6-32FCFA6BEC0A}" type="datetimeFigureOut">
              <a:rPr kumimoji="1" lang="ja-JP" altLang="en-US" smtClean="0"/>
              <a:t>2019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2959B-B7A4-4334-828C-1A610744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0738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8CC5B-1855-49EF-ACD6-32FCFA6BEC0A}" type="datetimeFigureOut">
              <a:rPr kumimoji="1" lang="ja-JP" altLang="en-US" smtClean="0"/>
              <a:t>2019/1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2959B-B7A4-4334-828C-1A610744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4112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8CC5B-1855-49EF-ACD6-32FCFA6BEC0A}" type="datetimeFigureOut">
              <a:rPr kumimoji="1" lang="ja-JP" altLang="en-US" smtClean="0"/>
              <a:t>2019/1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2959B-B7A4-4334-828C-1A610744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1926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8CC5B-1855-49EF-ACD6-32FCFA6BEC0A}" type="datetimeFigureOut">
              <a:rPr kumimoji="1" lang="ja-JP" altLang="en-US" smtClean="0"/>
              <a:t>2019/1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2959B-B7A4-4334-828C-1A610744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188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8CC5B-1855-49EF-ACD6-32FCFA6BEC0A}" type="datetimeFigureOut">
              <a:rPr kumimoji="1" lang="ja-JP" altLang="en-US" smtClean="0"/>
              <a:t>2019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2959B-B7A4-4334-828C-1A610744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5548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8CC5B-1855-49EF-ACD6-32FCFA6BEC0A}" type="datetimeFigureOut">
              <a:rPr kumimoji="1" lang="ja-JP" altLang="en-US" smtClean="0"/>
              <a:t>2019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2959B-B7A4-4334-828C-1A610744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6051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8CC5B-1855-49EF-ACD6-32FCFA6BEC0A}" type="datetimeFigureOut">
              <a:rPr kumimoji="1" lang="ja-JP" altLang="en-US" smtClean="0"/>
              <a:t>2019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F2959B-B7A4-4334-828C-1A610744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3394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正方形/長方形 9"/>
          <p:cNvSpPr/>
          <p:nvPr/>
        </p:nvSpPr>
        <p:spPr>
          <a:xfrm>
            <a:off x="4304670" y="1320211"/>
            <a:ext cx="2847420" cy="25708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1413629" y="1320211"/>
            <a:ext cx="2809754" cy="25708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583039" y="981116"/>
            <a:ext cx="24709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Patients with random</a:t>
            </a:r>
            <a:r>
              <a:rPr kumimoji="1" lang="ja-JP" altLang="en-US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XCI</a:t>
            </a:r>
            <a:endParaRPr kumimoji="1"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346544" y="981116"/>
            <a:ext cx="2378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Patients with </a:t>
            </a:r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skewed XCI</a:t>
            </a:r>
            <a:endParaRPr kumimoji="1"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7231576" y="1320211"/>
            <a:ext cx="1225939" cy="25708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7256994" y="981116"/>
            <a:ext cx="1175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Male control</a:t>
            </a:r>
            <a:endParaRPr kumimoji="1"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pic>
        <p:nvPicPr>
          <p:cNvPr id="18" name="図 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0982" y="1552111"/>
            <a:ext cx="2669111" cy="1222273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0982" y="3018036"/>
            <a:ext cx="2637085" cy="765853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4"/>
          <a:srcRect l="5528"/>
          <a:stretch/>
        </p:blipFill>
        <p:spPr>
          <a:xfrm>
            <a:off x="4360862" y="1349830"/>
            <a:ext cx="2684960" cy="1424554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46544" y="3018036"/>
            <a:ext cx="2699277" cy="787255"/>
          </a:xfrm>
          <a:prstGeom prst="rect">
            <a:avLst/>
          </a:prstGeom>
        </p:spPr>
      </p:pic>
      <p:pic>
        <p:nvPicPr>
          <p:cNvPr id="23" name="図 2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69054" y="1445757"/>
            <a:ext cx="950981" cy="1328627"/>
          </a:xfrm>
          <a:prstGeom prst="rect">
            <a:avLst/>
          </a:prstGeom>
        </p:spPr>
      </p:pic>
      <p:pic>
        <p:nvPicPr>
          <p:cNvPr id="24" name="図 23"/>
          <p:cNvPicPr>
            <a:picLocks noChangeAspect="1"/>
          </p:cNvPicPr>
          <p:nvPr/>
        </p:nvPicPr>
        <p:blipFill rotWithShape="1">
          <a:blip r:embed="rId7"/>
          <a:srcRect t="26025"/>
          <a:stretch/>
        </p:blipFill>
        <p:spPr>
          <a:xfrm>
            <a:off x="7369054" y="3018035"/>
            <a:ext cx="950981" cy="765853"/>
          </a:xfrm>
          <a:prstGeom prst="rect">
            <a:avLst/>
          </a:prstGeom>
        </p:spPr>
      </p:pic>
      <p:sp>
        <p:nvSpPr>
          <p:cNvPr id="25" name="テキスト ボックス 24"/>
          <p:cNvSpPr txBox="1"/>
          <p:nvPr/>
        </p:nvSpPr>
        <p:spPr>
          <a:xfrm>
            <a:off x="759255" y="4633866"/>
            <a:ext cx="795379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Fig. </a:t>
            </a:r>
            <a:r>
              <a:rPr kumimoji="1" lang="en-US" altLang="ja-JP" sz="1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S1. </a:t>
            </a:r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Representative results of </a:t>
            </a:r>
            <a:r>
              <a:rPr kumimoji="1" lang="en-US" altLang="ja-JP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X </a:t>
            </a:r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hromosome inactivation analysis. 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The results of random and skewed</a:t>
            </a:r>
            <a:r>
              <a:rPr kumimoji="1" lang="ja-JP" altLang="en-US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X chromosome inactivation </a:t>
            </a:r>
            <a:r>
              <a:rPr kumimoji="1" lang="en-US" altLang="ja-JP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(XCI) </a:t>
            </a:r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in the patients, together with the results of a male control, are shown. The elimination of the single peak in the </a:t>
            </a:r>
            <a:r>
              <a:rPr kumimoji="1" lang="en-US" altLang="ja-JP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male</a:t>
            </a:r>
            <a:r>
              <a:rPr kumimoji="1" lang="ja-JP" altLang="en-US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ontrol </a:t>
            </a:r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sample after </a:t>
            </a:r>
            <a:r>
              <a:rPr kumimoji="1" lang="en-US" altLang="ja-JP" sz="1400" i="1" dirty="0" err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Hpa</a:t>
            </a:r>
            <a:r>
              <a:rPr kumimoji="1" lang="en-US" altLang="ja-JP" sz="1400" dirty="0" err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II</a:t>
            </a:r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digestion </a:t>
            </a:r>
            <a:r>
              <a:rPr kumimoji="1" lang="en-US" altLang="ja-JP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onfirms a complete </a:t>
            </a:r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enzymatic reaction. </a:t>
            </a:r>
            <a:endParaRPr kumimoji="1"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811335" y="3939063"/>
            <a:ext cx="7977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6.8%</a:t>
            </a:r>
            <a:endParaRPr kumimoji="1"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3429564" y="3939063"/>
            <a:ext cx="74251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63.2% 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736151" y="3939063"/>
            <a:ext cx="7977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13.3%</a:t>
            </a:r>
            <a:endParaRPr kumimoji="1"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6354380" y="3939063"/>
            <a:ext cx="7977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86.3%</a:t>
            </a:r>
            <a:endParaRPr kumimoji="1"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52583" y="2062107"/>
            <a:ext cx="10923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Undigested </a:t>
            </a:r>
            <a:endParaRPr kumimoji="1"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55985" y="3137053"/>
            <a:ext cx="11743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i="1" dirty="0" err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Hpa</a:t>
            </a:r>
            <a:r>
              <a:rPr kumimoji="1" lang="en-US" altLang="ja-JP" sz="1400" dirty="0" err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II</a:t>
            </a:r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digested</a:t>
            </a:r>
            <a:endParaRPr kumimoji="1"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38897" y="3939063"/>
            <a:ext cx="101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XCI ratio</a:t>
            </a:r>
            <a:endParaRPr kumimoji="1" lang="ja-JP" altLang="en-US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11703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3</TotalTime>
  <Words>83</Words>
  <Application>Microsoft Office PowerPoint</Application>
  <PresentationFormat>画面に合わせる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Arial Unicode MS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2586  random</dc:title>
  <dc:creator>Yoshida</dc:creator>
  <cp:lastModifiedBy>深見 真紀</cp:lastModifiedBy>
  <cp:revision>55</cp:revision>
  <dcterms:created xsi:type="dcterms:W3CDTF">2018-08-27T02:25:13Z</dcterms:created>
  <dcterms:modified xsi:type="dcterms:W3CDTF">2019-12-07T03:34:47Z</dcterms:modified>
</cp:coreProperties>
</file>